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  <p:sldId id="259" r:id="rId3"/>
    <p:sldId id="256" r:id="rId4"/>
    <p:sldId id="263" r:id="rId5"/>
    <p:sldId id="265" r:id="rId6"/>
    <p:sldId id="260" r:id="rId7"/>
    <p:sldId id="264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73A13"/>
    <a:srgbClr val="FE6054"/>
    <a:srgbClr val="4D617A"/>
    <a:srgbClr val="FE857D"/>
    <a:srgbClr val="8397B0"/>
    <a:srgbClr val="FE5A51"/>
    <a:srgbClr val="295F8B"/>
    <a:srgbClr val="8A0000"/>
    <a:srgbClr val="8D0707"/>
    <a:srgbClr val="ED7D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74" autoAdjust="0"/>
    <p:restoredTop sz="94660"/>
  </p:normalViewPr>
  <p:slideViewPr>
    <p:cSldViewPr snapToGrid="0" showGuides="1">
      <p:cViewPr varScale="1">
        <p:scale>
          <a:sx n="88" d="100"/>
          <a:sy n="88" d="100"/>
        </p:scale>
        <p:origin x="2800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3848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8695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4232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4392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6241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55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0470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8175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645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3573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7956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6CA813-6AB3-4890-9D3D-DB9D96BCB527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1A42F0-3550-45B2-AE4F-6D5ED194E3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5901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7420" y="1193314"/>
            <a:ext cx="4091841" cy="499512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377420" y="593150"/>
            <a:ext cx="401463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1: Table S1. </a:t>
            </a:r>
            <a:r>
              <a:rPr lang="en-US" altLang="ko-KR" sz="1100" dirty="0" err="1">
                <a:latin typeface="Arial" panose="020B0604020202020204" pitchFamily="34" charset="0"/>
                <a:cs typeface="Arial" panose="020B0604020202020204" pitchFamily="34" charset="0"/>
              </a:rPr>
              <a:t>Clinicopathological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features of 29 patients with OSCC, and association between Par3 expression these variables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9711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1280512" y="3697931"/>
            <a:ext cx="429819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Figure S1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he expression pattern of HIF-1α in OSCC. The IHC scores were classified as negative, low and high expression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7299" y="925456"/>
            <a:ext cx="4297680" cy="27492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28577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/>
          <p:cNvSpPr txBox="1"/>
          <p:nvPr/>
        </p:nvSpPr>
        <p:spPr>
          <a:xfrm>
            <a:off x="1080421" y="2992439"/>
            <a:ext cx="429819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Figure S2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he expression of HIF-1α has nothing to do with tumor growth in vivo. HSC-2 cells treated with or without hypoxic conditions and siRNA-HIF-1α were subcutaneously injected into the BALB/c nude mice.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The image and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growth curve of tumor volume was measured in mice xenografts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그림 3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0752" y="868640"/>
            <a:ext cx="4090416" cy="21092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17503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7"/>
          <p:cNvSpPr txBox="1"/>
          <p:nvPr/>
        </p:nvSpPr>
        <p:spPr>
          <a:xfrm>
            <a:off x="178783" y="2875943"/>
            <a:ext cx="6411349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Figure S3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he expression of Par3 is negatively correlated with metastatic properties of OSCC. The mRNA expression of Par3 were significantly increased in patient cohort with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HNSC and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OSCC, compared with paired normal tissue. Results were retrieved from TCGA and GSE37991, respectively. Each lines represented paired adjacent normal tissues. * indicates significance differences between tumor and normal tissues (</a:t>
            </a:r>
            <a:r>
              <a:rPr lang="en-US" altLang="ko-KR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5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The mRNA and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protein expression of Par3 were decreased in metastatic patient cohort and tissues of OSCC, compared with non-metastatic OSCC tissues. Patient cohort was retrieved from GSE2880 (n=14). The black box indicates cropped fields of original images. * indicates significance differences between metastatic and non-metastatic OSCC (</a:t>
            </a:r>
            <a:r>
              <a:rPr lang="en-US" altLang="ko-KR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5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그림 4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148" y="597746"/>
            <a:ext cx="6461760" cy="23042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9652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1400629" y="2674881"/>
            <a:ext cx="377442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Figure S4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he expression of Par3 has nothing to do with tumor growth in vivo. HSC-2 cells treated with or without siRNA-Par3 were subcutaneously injected into the BALB/c nude mice.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The image and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growth curve of tumor volume was measured in mice xenografts.</a:t>
            </a:r>
            <a:endParaRPr lang="ko-KR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그림 3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4503" y="873404"/>
            <a:ext cx="4023360" cy="18531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62023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/>
          <p:cNvSpPr txBox="1"/>
          <p:nvPr/>
        </p:nvSpPr>
        <p:spPr>
          <a:xfrm>
            <a:off x="178783" y="4202680"/>
            <a:ext cx="641134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Figure S5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Morphologic changes are reflected in invasion ability of the OSCC cell lines.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The image represents the phase-contrast images of cell morphology of HSC-2, SCC-9 and SCC-25 cell lines. Scale bar, 100 µm.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the image represents the invaded number of HSC-2, SCC-9 and SCC-25 cells from upper chamber by </a:t>
            </a:r>
            <a:r>
              <a:rPr lang="en-US" altLang="ko-KR" sz="1100" dirty="0" err="1">
                <a:latin typeface="Arial" panose="020B0604020202020204" pitchFamily="34" charset="0"/>
                <a:cs typeface="Arial" panose="020B0604020202020204" pitchFamily="34" charset="0"/>
              </a:rPr>
              <a:t>matrigel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invasion assay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그림 4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739" y="874606"/>
            <a:ext cx="6205728" cy="3279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30075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19" t="13625" r="14166" b="25529"/>
          <a:stretch/>
        </p:blipFill>
        <p:spPr>
          <a:xfrm>
            <a:off x="514350" y="793750"/>
            <a:ext cx="5886450" cy="335119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8783" y="4202680"/>
            <a:ext cx="641134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Figure S6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A graphic model for the role of hypoxic conditions in OSCC. Hypoxic conditions are involved with disruption of tight junctions and promotes the metastatic properties of OSCC by Par3.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0206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86</TotalTime>
  <Words>396</Words>
  <Application>Microsoft Office PowerPoint</Application>
  <PresentationFormat>Letter 용지(8.5x11in)</PresentationFormat>
  <Paragraphs>7</Paragraphs>
  <Slides>7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3" baseType="lpstr">
      <vt:lpstr>맑은 고딕</vt:lpstr>
      <vt:lpstr>Arial</vt:lpstr>
      <vt:lpstr>Calibri</vt:lpstr>
      <vt:lpstr>Calibri Light</vt:lpstr>
      <vt:lpstr>Office 테마</vt:lpstr>
      <vt:lpstr>Prism 9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H Choi</dc:creator>
  <cp:lastModifiedBy>user</cp:lastModifiedBy>
  <cp:revision>102</cp:revision>
  <dcterms:created xsi:type="dcterms:W3CDTF">2022-09-19T06:39:41Z</dcterms:created>
  <dcterms:modified xsi:type="dcterms:W3CDTF">2022-12-14T14:54:25Z</dcterms:modified>
</cp:coreProperties>
</file>